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ED4CFF"/>
    <a:srgbClr val="A473FF"/>
    <a:srgbClr val="FF9C4B"/>
    <a:srgbClr val="A1C447"/>
    <a:srgbClr val="8B961D"/>
    <a:srgbClr val="68CF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85" autoAdjust="0"/>
    <p:restoredTop sz="94852" autoAdjust="0"/>
  </p:normalViewPr>
  <p:slideViewPr>
    <p:cSldViewPr snapToGrid="0" snapToObjects="1">
      <p:cViewPr>
        <p:scale>
          <a:sx n="152" d="100"/>
          <a:sy n="152" d="100"/>
        </p:scale>
        <p:origin x="-616" y="-6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DA6643-8E32-9A4C-AD52-F8801A2A5AF1}" type="datetimeFigureOut">
              <a:rPr lang="en-US" smtClean="0"/>
              <a:t>9/30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CE494E-83A9-D94F-9BBD-407B3C248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9454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379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084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069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93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529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177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129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030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587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290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958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800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191657"/>
              </p:ext>
            </p:extLst>
          </p:nvPr>
        </p:nvGraphicFramePr>
        <p:xfrm>
          <a:off x="158750" y="381000"/>
          <a:ext cx="3057258" cy="3292391"/>
        </p:xfrm>
        <a:graphic>
          <a:graphicData uri="http://schemas.openxmlformats.org/drawingml/2006/table">
            <a:tbl>
              <a:tblPr/>
              <a:tblGrid>
                <a:gridCol w="901071"/>
                <a:gridCol w="931911"/>
                <a:gridCol w="1224276"/>
              </a:tblGrid>
              <a:tr h="2443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ystematic nam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tandard 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Nam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old increase in Class 3 cells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MR247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3.27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333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QC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.3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PL106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SE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.14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GR135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RE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.1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021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IRC2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1.47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AL040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LN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4.06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OR026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BUB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1.80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PR120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LB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1.73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IC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3.14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PR095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YT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.28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PL178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BC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.9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ML017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SP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.44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GL213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KI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1.69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AL013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DEP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.35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OR293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PS10A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1.69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083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RP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1.46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-5479" y="13596"/>
            <a:ext cx="34247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Supplementary file </a:t>
            </a:r>
            <a:r>
              <a:rPr lang="en-US" sz="800" dirty="0" smtClean="0">
                <a:latin typeface="Helvetica"/>
                <a:cs typeface="Helvetica"/>
              </a:rPr>
              <a:t>1  </a:t>
            </a:r>
            <a:r>
              <a:rPr lang="en-US" sz="800" dirty="0" smtClean="0">
                <a:latin typeface="Helvetica"/>
                <a:cs typeface="Helvetica"/>
              </a:rPr>
              <a:t>List of confirmed mutants from the HCM-based</a:t>
            </a:r>
          </a:p>
          <a:p>
            <a:r>
              <a:rPr lang="en-US" sz="800" dirty="0" smtClean="0">
                <a:latin typeface="Helvetica"/>
                <a:cs typeface="Helvetica"/>
              </a:rPr>
              <a:t>screen that have increased Class 3 cells </a:t>
            </a:r>
            <a:endParaRPr lang="en-US" sz="8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446975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>
          <a:tailEnd type="arrow"/>
        </a:ln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23</TotalTime>
  <Words>77</Words>
  <Application>Microsoft Macintosh PowerPoint</Application>
  <PresentationFormat>On-screen Show (4:3)</PresentationFormat>
  <Paragraphs>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Nyström</dc:creator>
  <cp:lastModifiedBy>Junsheng Yang</cp:lastModifiedBy>
  <cp:revision>1208</cp:revision>
  <cp:lastPrinted>2014-10-20T06:32:57Z</cp:lastPrinted>
  <dcterms:created xsi:type="dcterms:W3CDTF">2013-02-25T19:20:10Z</dcterms:created>
  <dcterms:modified xsi:type="dcterms:W3CDTF">2015-10-01T03:59:52Z</dcterms:modified>
</cp:coreProperties>
</file>